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100" d="100"/>
          <a:sy n="100" d="100"/>
        </p:scale>
        <p:origin x="774" y="-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d.docs.live.net/6039f1d458c78cad/&#30740;&#31350;/D13LPC%20time%20course%20n=4%20fin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D13LPC time course n=4 final.xlsx]まとめ（LDL層） エラーバーつき (4)'!$AV$61</c:f>
              <c:strCache>
                <c:ptCount val="1"/>
                <c:pt idx="0">
                  <c:v>HDL(+)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D13LPC time course n=4 final.xlsx]まとめ（LDL層） エラーバーつき (4)'!$BB$61:$BE$61</c:f>
                <c:numCache>
                  <c:formatCode>General</c:formatCode>
                  <c:ptCount val="4"/>
                  <c:pt idx="0">
                    <c:v>2.8869513665409205</c:v>
                  </c:pt>
                  <c:pt idx="1">
                    <c:v>13.864298941163973</c:v>
                  </c:pt>
                  <c:pt idx="2">
                    <c:v>18.920951665373646</c:v>
                  </c:pt>
                  <c:pt idx="3">
                    <c:v>15.042820245421321</c:v>
                  </c:pt>
                </c:numCache>
              </c:numRef>
            </c:plus>
            <c:minus>
              <c:numRef>
                <c:f>'[D13LPC time course n=4 final.xlsx]まとめ（LDL層） エラーバーつき (4)'!$BB$61:$BE$61</c:f>
                <c:numCache>
                  <c:formatCode>General</c:formatCode>
                  <c:ptCount val="4"/>
                  <c:pt idx="0">
                    <c:v>2.8869513665409205</c:v>
                  </c:pt>
                  <c:pt idx="1">
                    <c:v>13.864298941163973</c:v>
                  </c:pt>
                  <c:pt idx="2">
                    <c:v>18.920951665373646</c:v>
                  </c:pt>
                  <c:pt idx="3">
                    <c:v>15.04282024542132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D13LPC time course n=4 final.xlsx]まとめ（LDL層） エラーバーつき (4)'!$AW$60:$AZ$6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cat>
          <c:val>
            <c:numRef>
              <c:f>'[D13LPC time course n=4 final.xlsx]まとめ（LDL層） エラーバーつき (4)'!$AW$61:$AZ$61</c:f>
              <c:numCache>
                <c:formatCode>0.0</c:formatCode>
                <c:ptCount val="4"/>
                <c:pt idx="0">
                  <c:v>92.115401039770347</c:v>
                </c:pt>
                <c:pt idx="1">
                  <c:v>67.088381717214574</c:v>
                </c:pt>
                <c:pt idx="2">
                  <c:v>47.815486717063479</c:v>
                </c:pt>
                <c:pt idx="3">
                  <c:v>32.9833217287501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EE-4EED-9CF1-2BCBA568C114}"/>
            </c:ext>
          </c:extLst>
        </c:ser>
        <c:ser>
          <c:idx val="1"/>
          <c:order val="1"/>
          <c:tx>
            <c:strRef>
              <c:f>'[D13LPC time course n=4 final.xlsx]まとめ（LDL層） エラーバーつき (4)'!$AV$62</c:f>
              <c:strCache>
                <c:ptCount val="1"/>
                <c:pt idx="0">
                  <c:v>HDL(-)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D13LPC time course n=4 final.xlsx]まとめ（LDL層） エラーバーつき (4)'!$BB$62:$BE$62</c:f>
                <c:numCache>
                  <c:formatCode>General</c:formatCode>
                  <c:ptCount val="4"/>
                  <c:pt idx="0">
                    <c:v>7.5527813693907764E-2</c:v>
                  </c:pt>
                  <c:pt idx="1">
                    <c:v>3.1285719178939662</c:v>
                  </c:pt>
                  <c:pt idx="2">
                    <c:v>2.5943362358675786</c:v>
                  </c:pt>
                  <c:pt idx="3">
                    <c:v>2.2853596603954678</c:v>
                  </c:pt>
                </c:numCache>
              </c:numRef>
            </c:plus>
            <c:minus>
              <c:numRef>
                <c:f>'[D13LPC time course n=4 final.xlsx]まとめ（LDL層） エラーバーつき (4)'!$BB$62:$BE$62</c:f>
                <c:numCache>
                  <c:formatCode>General</c:formatCode>
                  <c:ptCount val="4"/>
                  <c:pt idx="0">
                    <c:v>7.5527813693907764E-2</c:v>
                  </c:pt>
                  <c:pt idx="1">
                    <c:v>3.1285719178939662</c:v>
                  </c:pt>
                  <c:pt idx="2">
                    <c:v>2.5943362358675786</c:v>
                  </c:pt>
                  <c:pt idx="3">
                    <c:v>2.285359660395467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D13LPC time course n=4 final.xlsx]まとめ（LDL層） エラーバーつき (4)'!$AW$60:$AZ$6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cat>
          <c:val>
            <c:numRef>
              <c:f>'[D13LPC time course n=4 final.xlsx]まとめ（LDL層） エラーバーつき (4)'!$AW$62:$AZ$62</c:f>
              <c:numCache>
                <c:formatCode>0.0</c:formatCode>
                <c:ptCount val="4"/>
                <c:pt idx="0">
                  <c:v>99.572853795075503</c:v>
                </c:pt>
                <c:pt idx="1">
                  <c:v>92.929765043159847</c:v>
                </c:pt>
                <c:pt idx="2">
                  <c:v>92.516407402687037</c:v>
                </c:pt>
                <c:pt idx="3">
                  <c:v>92.918670046548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EE-4EED-9CF1-2BCBA568C1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0"/>
        <c:axId val="370979272"/>
        <c:axId val="370977632"/>
      </c:barChart>
      <c:catAx>
        <c:axId val="370979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977632"/>
        <c:crosses val="autoZero"/>
        <c:auto val="1"/>
        <c:lblAlgn val="ctr"/>
        <c:lblOffset val="100"/>
        <c:noMultiLvlLbl val="0"/>
      </c:catAx>
      <c:valAx>
        <c:axId val="370977632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0979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403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3226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6598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335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37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574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905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365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831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816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448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DE8B4-8485-4F58-91C4-7B0086C6A2C7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57765-EAA7-41F6-BDC4-E8A60A6A2B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1735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90615217-7030-411C-88A7-E2E1D24FE331}"/>
              </a:ext>
            </a:extLst>
          </p:cNvPr>
          <p:cNvGraphicFramePr>
            <a:graphicFrameLocks/>
          </p:cNvGraphicFramePr>
          <p:nvPr/>
        </p:nvGraphicFramePr>
        <p:xfrm>
          <a:off x="1365554" y="1570390"/>
          <a:ext cx="3413532" cy="2594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0C6ACF6-7D9C-4757-89A4-497EBCCADCA3}"/>
              </a:ext>
            </a:extLst>
          </p:cNvPr>
          <p:cNvSpPr txBox="1"/>
          <p:nvPr/>
        </p:nvSpPr>
        <p:spPr>
          <a:xfrm>
            <a:off x="364572" y="148221"/>
            <a:ext cx="2835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upplementary Figure S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21A601CD-D2A3-4A4D-92E0-B6D9BC8A8857}"/>
              </a:ext>
            </a:extLst>
          </p:cNvPr>
          <p:cNvGrpSpPr/>
          <p:nvPr/>
        </p:nvGrpSpPr>
        <p:grpSpPr>
          <a:xfrm>
            <a:off x="3561129" y="1058688"/>
            <a:ext cx="1932945" cy="461665"/>
            <a:chOff x="2211856" y="1359247"/>
            <a:chExt cx="1932945" cy="461665"/>
          </a:xfrm>
        </p:grpSpPr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87346DE7-518C-451B-96D4-E72037F052D7}"/>
                </a:ext>
              </a:extLst>
            </p:cNvPr>
            <p:cNvSpPr/>
            <p:nvPr/>
          </p:nvSpPr>
          <p:spPr>
            <a:xfrm>
              <a:off x="2211856" y="1458100"/>
              <a:ext cx="216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C9FBD10B-4516-4938-84EE-992741D3F2E3}"/>
                </a:ext>
              </a:extLst>
            </p:cNvPr>
            <p:cNvSpPr/>
            <p:nvPr/>
          </p:nvSpPr>
          <p:spPr>
            <a:xfrm>
              <a:off x="2215975" y="1635214"/>
              <a:ext cx="216000" cy="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8C8457EC-D3E8-4D51-90B9-0BB86B759DC1}"/>
                </a:ext>
              </a:extLst>
            </p:cNvPr>
            <p:cNvSpPr txBox="1"/>
            <p:nvPr/>
          </p:nvSpPr>
          <p:spPr>
            <a:xfrm>
              <a:off x="2397207" y="1359247"/>
              <a:ext cx="17475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incubated with HDL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incubated without HDL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364FF47-5EA1-43E0-B498-BFE78900051E}"/>
              </a:ext>
            </a:extLst>
          </p:cNvPr>
          <p:cNvSpPr txBox="1"/>
          <p:nvPr/>
        </p:nvSpPr>
        <p:spPr>
          <a:xfrm rot="16200000">
            <a:off x="230702" y="2498142"/>
            <a:ext cx="19587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kumimoji="0" lang="en-US" altLang="ja-JP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</a:t>
            </a: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lysoPC in LDL fraction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% of total d</a:t>
            </a:r>
            <a:r>
              <a:rPr kumimoji="0" lang="en-US" altLang="ja-JP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</a:t>
            </a: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PCs)</a:t>
            </a:r>
            <a:endParaRPr kumimoji="0" lang="ja-JP" altLang="ja-JP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37CF21B-B3E8-4499-BE56-4F022363FF96}"/>
              </a:ext>
            </a:extLst>
          </p:cNvPr>
          <p:cNvSpPr txBox="1"/>
          <p:nvPr/>
        </p:nvSpPr>
        <p:spPr>
          <a:xfrm>
            <a:off x="2467626" y="4087917"/>
            <a:ext cx="1457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cubation time (h)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0EB554E-398B-4B7B-B4B2-F71025AEE872}"/>
              </a:ext>
            </a:extLst>
          </p:cNvPr>
          <p:cNvSpPr txBox="1"/>
          <p:nvPr/>
        </p:nvSpPr>
        <p:spPr>
          <a:xfrm>
            <a:off x="3869233" y="1603162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s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6B78E31-6361-4AC6-8FF3-CAB3C05AB132}"/>
              </a:ext>
            </a:extLst>
          </p:cNvPr>
          <p:cNvSpPr txBox="1"/>
          <p:nvPr/>
        </p:nvSpPr>
        <p:spPr>
          <a:xfrm>
            <a:off x="3155249" y="1598535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s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759E8876-789C-41DA-BE2C-7E67F647E962}"/>
              </a:ext>
            </a:extLst>
          </p:cNvPr>
          <p:cNvCxnSpPr/>
          <p:nvPr/>
        </p:nvCxnSpPr>
        <p:spPr>
          <a:xfrm>
            <a:off x="2298763" y="1819362"/>
            <a:ext cx="64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9B5A1775-3D7F-448C-9B06-686B153FD910}"/>
              </a:ext>
            </a:extLst>
          </p:cNvPr>
          <p:cNvGrpSpPr/>
          <p:nvPr/>
        </p:nvGrpSpPr>
        <p:grpSpPr>
          <a:xfrm>
            <a:off x="2435683" y="1647956"/>
            <a:ext cx="428079" cy="246259"/>
            <a:chOff x="2218114" y="1999224"/>
            <a:chExt cx="428079" cy="246259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0A05F59E-02A2-4E00-AC0D-CCD020FD91D6}"/>
                </a:ext>
              </a:extLst>
            </p:cNvPr>
            <p:cNvSpPr txBox="1"/>
            <p:nvPr/>
          </p:nvSpPr>
          <p:spPr>
            <a:xfrm>
              <a:off x="2218114" y="1999262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72C13433-41F1-4D1F-9F59-F2E9264E1C41}"/>
                </a:ext>
              </a:extLst>
            </p:cNvPr>
            <p:cNvSpPr txBox="1"/>
            <p:nvPr/>
          </p:nvSpPr>
          <p:spPr>
            <a:xfrm>
              <a:off x="2305321" y="1999224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</p:grp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E5A430B4-5DF0-42A7-BA56-1032EF301DB9}"/>
              </a:ext>
            </a:extLst>
          </p:cNvPr>
          <p:cNvCxnSpPr/>
          <p:nvPr/>
        </p:nvCxnSpPr>
        <p:spPr>
          <a:xfrm>
            <a:off x="3026610" y="1821987"/>
            <a:ext cx="68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3E645D6A-77AC-4FC9-93B3-AE6221B0BEC8}"/>
              </a:ext>
            </a:extLst>
          </p:cNvPr>
          <p:cNvCxnSpPr/>
          <p:nvPr/>
        </p:nvCxnSpPr>
        <p:spPr>
          <a:xfrm>
            <a:off x="3762340" y="1812084"/>
            <a:ext cx="64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B36C1ECC-A297-468B-9EF1-3D5EADBD65C9}"/>
              </a:ext>
            </a:extLst>
          </p:cNvPr>
          <p:cNvGrpSpPr/>
          <p:nvPr/>
        </p:nvGrpSpPr>
        <p:grpSpPr>
          <a:xfrm>
            <a:off x="1945026" y="1806576"/>
            <a:ext cx="428079" cy="246259"/>
            <a:chOff x="2218114" y="1999224"/>
            <a:chExt cx="428079" cy="246259"/>
          </a:xfrm>
        </p:grpSpPr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F7751D6F-E72A-4349-9A40-2582C4DC4631}"/>
                </a:ext>
              </a:extLst>
            </p:cNvPr>
            <p:cNvSpPr txBox="1"/>
            <p:nvPr/>
          </p:nvSpPr>
          <p:spPr>
            <a:xfrm>
              <a:off x="2218114" y="1999262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4D06990-7716-4929-8B89-71FC510576D3}"/>
                </a:ext>
              </a:extLst>
            </p:cNvPr>
            <p:cNvSpPr txBox="1"/>
            <p:nvPr/>
          </p:nvSpPr>
          <p:spPr>
            <a:xfrm>
              <a:off x="2305321" y="1999224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643AA301-D5CE-4959-8E5B-34D47A913259}"/>
              </a:ext>
            </a:extLst>
          </p:cNvPr>
          <p:cNvGrpSpPr/>
          <p:nvPr/>
        </p:nvGrpSpPr>
        <p:grpSpPr>
          <a:xfrm>
            <a:off x="3352447" y="1895830"/>
            <a:ext cx="428079" cy="246259"/>
            <a:chOff x="2218114" y="1999224"/>
            <a:chExt cx="428079" cy="246259"/>
          </a:xfrm>
        </p:grpSpPr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E369281D-2909-4F37-97E6-390F6B718515}"/>
                </a:ext>
              </a:extLst>
            </p:cNvPr>
            <p:cNvSpPr txBox="1"/>
            <p:nvPr/>
          </p:nvSpPr>
          <p:spPr>
            <a:xfrm>
              <a:off x="2218114" y="1999262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0A4E6AC9-8B61-495A-8026-EB90DA4C8626}"/>
                </a:ext>
              </a:extLst>
            </p:cNvPr>
            <p:cNvSpPr txBox="1"/>
            <p:nvPr/>
          </p:nvSpPr>
          <p:spPr>
            <a:xfrm>
              <a:off x="2305321" y="1999224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450108B3-EA02-47B6-BEA1-9EC849931E3A}"/>
              </a:ext>
            </a:extLst>
          </p:cNvPr>
          <p:cNvGrpSpPr/>
          <p:nvPr/>
        </p:nvGrpSpPr>
        <p:grpSpPr>
          <a:xfrm>
            <a:off x="4084756" y="1896800"/>
            <a:ext cx="428079" cy="246259"/>
            <a:chOff x="2218114" y="1999224"/>
            <a:chExt cx="428079" cy="246259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3736430-E4AC-4200-AB6D-1518E514B9AD}"/>
                </a:ext>
              </a:extLst>
            </p:cNvPr>
            <p:cNvSpPr txBox="1"/>
            <p:nvPr/>
          </p:nvSpPr>
          <p:spPr>
            <a:xfrm>
              <a:off x="2218114" y="1999262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C0CCA372-C516-4272-A804-DC968E3E5336}"/>
                </a:ext>
              </a:extLst>
            </p:cNvPr>
            <p:cNvSpPr txBox="1"/>
            <p:nvPr/>
          </p:nvSpPr>
          <p:spPr>
            <a:xfrm>
              <a:off x="2305321" y="1999224"/>
              <a:ext cx="340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＊</a:t>
              </a:r>
            </a:p>
          </p:txBody>
        </p:sp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00B51FC-6213-46E3-A82A-5C004D167161}"/>
              </a:ext>
            </a:extLst>
          </p:cNvPr>
          <p:cNvSpPr txBox="1"/>
          <p:nvPr/>
        </p:nvSpPr>
        <p:spPr>
          <a:xfrm>
            <a:off x="2704749" y="1866617"/>
            <a:ext cx="3408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＊</a:t>
            </a: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3C8EA6F6-E231-4946-861C-8B6D04B7F9AB}"/>
              </a:ext>
            </a:extLst>
          </p:cNvPr>
          <p:cNvCxnSpPr/>
          <p:nvPr/>
        </p:nvCxnSpPr>
        <p:spPr>
          <a:xfrm>
            <a:off x="4127682" y="2064692"/>
            <a:ext cx="27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6A2E3E78-0C57-4569-91E4-84C8EE98291E}"/>
              </a:ext>
            </a:extLst>
          </p:cNvPr>
          <p:cNvCxnSpPr/>
          <p:nvPr/>
        </p:nvCxnSpPr>
        <p:spPr>
          <a:xfrm>
            <a:off x="3415788" y="2054254"/>
            <a:ext cx="27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A8FA6148-F07A-4C49-8B07-4EC12DE8F9FB}"/>
              </a:ext>
            </a:extLst>
          </p:cNvPr>
          <p:cNvCxnSpPr/>
          <p:nvPr/>
        </p:nvCxnSpPr>
        <p:spPr>
          <a:xfrm>
            <a:off x="2703894" y="2043816"/>
            <a:ext cx="27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86687F98-6DED-4A41-BDB9-4D2DF9334BDC}"/>
              </a:ext>
            </a:extLst>
          </p:cNvPr>
          <p:cNvCxnSpPr/>
          <p:nvPr/>
        </p:nvCxnSpPr>
        <p:spPr>
          <a:xfrm>
            <a:off x="2004526" y="1983274"/>
            <a:ext cx="27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7FD6F0C9-66B9-4725-9174-BB0D659DFD86}"/>
              </a:ext>
            </a:extLst>
          </p:cNvPr>
          <p:cNvSpPr txBox="1"/>
          <p:nvPr/>
        </p:nvSpPr>
        <p:spPr>
          <a:xfrm>
            <a:off x="485775" y="5165872"/>
            <a:ext cx="58864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2.  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 of HDL decreased d</a:t>
            </a:r>
            <a:r>
              <a:rPr kumimoji="0" lang="en-US" altLang="ja-JP" sz="120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lysoPC labeled in LDL. Recovery</a:t>
            </a:r>
            <a:r>
              <a:rPr kumimoji="0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f</a:t>
            </a:r>
            <a:r>
              <a:rPr kumimoji="0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</a:t>
            </a:r>
            <a:r>
              <a:rPr kumimoji="0" lang="en-US" altLang="ja-JP" sz="12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lysoPC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as</a:t>
            </a:r>
            <a:r>
              <a:rPr lang="ja-JP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pressed</a:t>
            </a:r>
            <a:r>
              <a:rPr lang="ja-JP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s</a:t>
            </a:r>
            <a:r>
              <a:rPr lang="ja-JP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relative ratio to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he total d</a:t>
            </a:r>
            <a:r>
              <a:rPr kumimoji="0" lang="en-US" altLang="ja-JP" sz="12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labeled PC (21 species) in the re-isolated LDL fraction. </a:t>
            </a:r>
            <a:r>
              <a:rPr kumimoji="0" lang="ja-JP" alt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＊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 &lt; 0.05,</a:t>
            </a:r>
            <a:r>
              <a:rPr kumimoji="0" lang="ja-JP" alt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**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 &lt; 0.01, ns: not significant. Results are mean (SD) of four independent experiments.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aired t-test was used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compare open and closed bars of each time point. Tukey-Kramer test was used to evaluate significant differences among the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pen bars.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018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4</TotalTime>
  <Words>124</Words>
  <Application>Microsoft Office PowerPoint</Application>
  <PresentationFormat>A4 210 x 297 mm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笹部 直子</dc:creator>
  <cp:lastModifiedBy>洋之 板部</cp:lastModifiedBy>
  <cp:revision>8</cp:revision>
  <dcterms:created xsi:type="dcterms:W3CDTF">2020-09-01T12:29:53Z</dcterms:created>
  <dcterms:modified xsi:type="dcterms:W3CDTF">2020-10-10T03:14:23Z</dcterms:modified>
</cp:coreProperties>
</file>